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4" d="100"/>
          <a:sy n="124" d="100"/>
        </p:scale>
        <p:origin x="594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3A7F5-7962-4379-8031-768DBCBF558C}" type="datetimeFigureOut">
              <a:rPr lang="en-US" smtClean="0"/>
              <a:t>11/3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5E85A-13DC-48C1-8C6E-4B79427B3A4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25365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3A7F5-7962-4379-8031-768DBCBF558C}" type="datetimeFigureOut">
              <a:rPr lang="en-US" smtClean="0"/>
              <a:t>11/3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5E85A-13DC-48C1-8C6E-4B79427B3A4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07740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3A7F5-7962-4379-8031-768DBCBF558C}" type="datetimeFigureOut">
              <a:rPr lang="en-US" smtClean="0"/>
              <a:t>11/3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5E85A-13DC-48C1-8C6E-4B79427B3A4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68310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3A7F5-7962-4379-8031-768DBCBF558C}" type="datetimeFigureOut">
              <a:rPr lang="en-US" smtClean="0"/>
              <a:t>11/3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5E85A-13DC-48C1-8C6E-4B79427B3A4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93178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3A7F5-7962-4379-8031-768DBCBF558C}" type="datetimeFigureOut">
              <a:rPr lang="en-US" smtClean="0"/>
              <a:t>11/3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5E85A-13DC-48C1-8C6E-4B79427B3A4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35805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3A7F5-7962-4379-8031-768DBCBF558C}" type="datetimeFigureOut">
              <a:rPr lang="en-US" smtClean="0"/>
              <a:t>11/3/2021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5E85A-13DC-48C1-8C6E-4B79427B3A4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42640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3A7F5-7962-4379-8031-768DBCBF558C}" type="datetimeFigureOut">
              <a:rPr lang="en-US" smtClean="0"/>
              <a:t>11/3/2021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5E85A-13DC-48C1-8C6E-4B79427B3A4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9730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3A7F5-7962-4379-8031-768DBCBF558C}" type="datetimeFigureOut">
              <a:rPr lang="en-US" smtClean="0"/>
              <a:t>11/3/2021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5E85A-13DC-48C1-8C6E-4B79427B3A4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26668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3A7F5-7962-4379-8031-768DBCBF558C}" type="datetimeFigureOut">
              <a:rPr lang="en-US" smtClean="0"/>
              <a:t>11/3/2021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5E85A-13DC-48C1-8C6E-4B79427B3A4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49726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3A7F5-7962-4379-8031-768DBCBF558C}" type="datetimeFigureOut">
              <a:rPr lang="en-US" smtClean="0"/>
              <a:t>11/3/2021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5E85A-13DC-48C1-8C6E-4B79427B3A4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80239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3A7F5-7962-4379-8031-768DBCBF558C}" type="datetimeFigureOut">
              <a:rPr lang="en-US" smtClean="0"/>
              <a:t>11/3/2021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5E85A-13DC-48C1-8C6E-4B79427B3A4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7079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23A7F5-7962-4379-8031-768DBCBF558C}" type="datetimeFigureOut">
              <a:rPr lang="en-US" smtClean="0"/>
              <a:t>11/3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55E85A-13DC-48C1-8C6E-4B79427B3A4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88728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81225" y="2052638"/>
            <a:ext cx="4781550" cy="2752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2" name="Gruppieren 1"/>
          <p:cNvGrpSpPr/>
          <p:nvPr/>
        </p:nvGrpSpPr>
        <p:grpSpPr>
          <a:xfrm>
            <a:off x="2819400" y="2072640"/>
            <a:ext cx="2743200" cy="137160"/>
            <a:chOff x="2819400" y="2133600"/>
            <a:chExt cx="2743200" cy="137160"/>
          </a:xfrm>
        </p:grpSpPr>
        <p:sp>
          <p:nvSpPr>
            <p:cNvPr id="11" name="Rechteck 10"/>
            <p:cNvSpPr/>
            <p:nvPr/>
          </p:nvSpPr>
          <p:spPr>
            <a:xfrm>
              <a:off x="2819400" y="2133600"/>
              <a:ext cx="1371600" cy="137160"/>
            </a:xfrm>
            <a:prstGeom prst="rect">
              <a:avLst/>
            </a:prstGeom>
            <a:solidFill>
              <a:schemeClr val="tx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9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F</a:t>
              </a:r>
              <a:endParaRPr lang="en-US" sz="9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Rechteck 11"/>
            <p:cNvSpPr/>
            <p:nvPr/>
          </p:nvSpPr>
          <p:spPr>
            <a:xfrm>
              <a:off x="4191000" y="2133600"/>
              <a:ext cx="1371600" cy="13716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900" b="1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C</a:t>
              </a:r>
              <a:endParaRPr lang="en-US" sz="9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3" name="Textfeld 12"/>
          <p:cNvSpPr txBox="1"/>
          <p:nvPr/>
        </p:nvSpPr>
        <p:spPr>
          <a:xfrm>
            <a:off x="1" y="5715000"/>
            <a:ext cx="914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ody weight of male C57BL6/J mice (n=6 for each time point) on standard chow diet (SC) only and diet switch starting with a coconut oil-based high-fat diet (HF) from age 8 to 32 weeks, followed by SC from 32 to 44 weeks. Statistics: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epeated measured ANOVA with post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Šídák’s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multiple comparison test p&lt;0.01**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&lt;0.001*** and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&lt;0.0001****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Gruppieren 9"/>
          <p:cNvGrpSpPr/>
          <p:nvPr/>
        </p:nvGrpSpPr>
        <p:grpSpPr>
          <a:xfrm>
            <a:off x="3303634" y="2451000"/>
            <a:ext cx="396262" cy="216000"/>
            <a:chOff x="3276600" y="2563200"/>
            <a:chExt cx="396262" cy="216000"/>
          </a:xfrm>
        </p:grpSpPr>
        <p:sp>
          <p:nvSpPr>
            <p:cNvPr id="4" name="Textfeld 3"/>
            <p:cNvSpPr txBox="1"/>
            <p:nvPr/>
          </p:nvSpPr>
          <p:spPr>
            <a:xfrm>
              <a:off x="3276600" y="2563200"/>
              <a:ext cx="396262" cy="2160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" name="Gerader Verbinder 4"/>
            <p:cNvCxnSpPr/>
            <p:nvPr/>
          </p:nvCxnSpPr>
          <p:spPr>
            <a:xfrm>
              <a:off x="3314700" y="2779200"/>
              <a:ext cx="32006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" name="Gruppieren 17"/>
          <p:cNvGrpSpPr/>
          <p:nvPr/>
        </p:nvGrpSpPr>
        <p:grpSpPr>
          <a:xfrm>
            <a:off x="3749934" y="2209800"/>
            <a:ext cx="466794" cy="216000"/>
            <a:chOff x="3276600" y="2563200"/>
            <a:chExt cx="466794" cy="216000"/>
          </a:xfrm>
        </p:grpSpPr>
        <p:sp>
          <p:nvSpPr>
            <p:cNvPr id="19" name="Textfeld 18"/>
            <p:cNvSpPr txBox="1"/>
            <p:nvPr/>
          </p:nvSpPr>
          <p:spPr>
            <a:xfrm>
              <a:off x="3276600" y="2563200"/>
              <a:ext cx="466794" cy="2160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*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" name="Gerader Verbinder 19"/>
            <p:cNvCxnSpPr/>
            <p:nvPr/>
          </p:nvCxnSpPr>
          <p:spPr>
            <a:xfrm>
              <a:off x="3349966" y="2779200"/>
              <a:ext cx="32006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1" name="Gruppieren 20"/>
          <p:cNvGrpSpPr/>
          <p:nvPr/>
        </p:nvGrpSpPr>
        <p:grpSpPr>
          <a:xfrm>
            <a:off x="4783872" y="2409917"/>
            <a:ext cx="325730" cy="216000"/>
            <a:chOff x="3292816" y="2563200"/>
            <a:chExt cx="325730" cy="216000"/>
          </a:xfrm>
        </p:grpSpPr>
        <p:sp>
          <p:nvSpPr>
            <p:cNvPr id="22" name="Textfeld 21"/>
            <p:cNvSpPr txBox="1"/>
            <p:nvPr/>
          </p:nvSpPr>
          <p:spPr>
            <a:xfrm>
              <a:off x="3292816" y="2563200"/>
              <a:ext cx="325730" cy="2160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3" name="Gerader Verbinder 22"/>
            <p:cNvCxnSpPr/>
            <p:nvPr/>
          </p:nvCxnSpPr>
          <p:spPr>
            <a:xfrm>
              <a:off x="3295650" y="2779200"/>
              <a:ext cx="32006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4" name="Gruppieren 23"/>
          <p:cNvGrpSpPr/>
          <p:nvPr/>
        </p:nvGrpSpPr>
        <p:grpSpPr>
          <a:xfrm>
            <a:off x="4297425" y="2438400"/>
            <a:ext cx="325730" cy="216000"/>
            <a:chOff x="3292816" y="2563200"/>
            <a:chExt cx="325730" cy="216000"/>
          </a:xfrm>
        </p:grpSpPr>
        <p:sp>
          <p:nvSpPr>
            <p:cNvPr id="25" name="Textfeld 24"/>
            <p:cNvSpPr txBox="1"/>
            <p:nvPr/>
          </p:nvSpPr>
          <p:spPr>
            <a:xfrm>
              <a:off x="3292816" y="2563200"/>
              <a:ext cx="325730" cy="2160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6" name="Gerader Verbinder 25"/>
            <p:cNvCxnSpPr/>
            <p:nvPr/>
          </p:nvCxnSpPr>
          <p:spPr>
            <a:xfrm>
              <a:off x="3295650" y="2779200"/>
              <a:ext cx="32006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550160601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7</Words>
  <Application>Microsoft Office PowerPoint</Application>
  <PresentationFormat>Bildschirmpräsentation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Arial</vt:lpstr>
      <vt:lpstr>Calibri</vt:lpstr>
      <vt:lpstr>Larissa</vt:lpstr>
      <vt:lpstr>PowerPoint-Präsentation</vt:lpstr>
    </vt:vector>
  </TitlesOfParts>
  <Company>Universitätsklinikum Leipzig Aö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dlen Reinicke</dc:creator>
  <cp:lastModifiedBy>Reinicke, Madlen</cp:lastModifiedBy>
  <cp:revision>11</cp:revision>
  <cp:lastPrinted>2020-06-11T08:28:39Z</cp:lastPrinted>
  <dcterms:created xsi:type="dcterms:W3CDTF">2020-04-22T08:42:28Z</dcterms:created>
  <dcterms:modified xsi:type="dcterms:W3CDTF">2021-11-04T07:06:14Z</dcterms:modified>
</cp:coreProperties>
</file>